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99" r:id="rId2"/>
  </p:sldIdLst>
  <p:sldSz cx="5029200" cy="6884988"/>
  <p:notesSz cx="9601200" cy="7315200"/>
  <p:defaultTextStyle>
    <a:defPPr>
      <a:defRPr lang="en-US"/>
    </a:defPPr>
    <a:lvl1pPr marL="0" algn="l" defTabSz="649864" rtl="0" eaLnBrk="1" latinLnBrk="0" hangingPunct="1">
      <a:defRPr sz="1279" kern="1200">
        <a:solidFill>
          <a:schemeClr val="tx1"/>
        </a:solidFill>
        <a:latin typeface="+mn-lt"/>
        <a:ea typeface="+mn-ea"/>
        <a:cs typeface="+mn-cs"/>
      </a:defRPr>
    </a:lvl1pPr>
    <a:lvl2pPr marL="324932" algn="l" defTabSz="649864" rtl="0" eaLnBrk="1" latinLnBrk="0" hangingPunct="1">
      <a:defRPr sz="1279" kern="1200">
        <a:solidFill>
          <a:schemeClr val="tx1"/>
        </a:solidFill>
        <a:latin typeface="+mn-lt"/>
        <a:ea typeface="+mn-ea"/>
        <a:cs typeface="+mn-cs"/>
      </a:defRPr>
    </a:lvl2pPr>
    <a:lvl3pPr marL="649864" algn="l" defTabSz="649864" rtl="0" eaLnBrk="1" latinLnBrk="0" hangingPunct="1">
      <a:defRPr sz="1279" kern="1200">
        <a:solidFill>
          <a:schemeClr val="tx1"/>
        </a:solidFill>
        <a:latin typeface="+mn-lt"/>
        <a:ea typeface="+mn-ea"/>
        <a:cs typeface="+mn-cs"/>
      </a:defRPr>
    </a:lvl3pPr>
    <a:lvl4pPr marL="974796" algn="l" defTabSz="649864" rtl="0" eaLnBrk="1" latinLnBrk="0" hangingPunct="1">
      <a:defRPr sz="1279" kern="1200">
        <a:solidFill>
          <a:schemeClr val="tx1"/>
        </a:solidFill>
        <a:latin typeface="+mn-lt"/>
        <a:ea typeface="+mn-ea"/>
        <a:cs typeface="+mn-cs"/>
      </a:defRPr>
    </a:lvl4pPr>
    <a:lvl5pPr marL="1299728" algn="l" defTabSz="649864" rtl="0" eaLnBrk="1" latinLnBrk="0" hangingPunct="1">
      <a:defRPr sz="1279" kern="1200">
        <a:solidFill>
          <a:schemeClr val="tx1"/>
        </a:solidFill>
        <a:latin typeface="+mn-lt"/>
        <a:ea typeface="+mn-ea"/>
        <a:cs typeface="+mn-cs"/>
      </a:defRPr>
    </a:lvl5pPr>
    <a:lvl6pPr marL="1624660" algn="l" defTabSz="649864" rtl="0" eaLnBrk="1" latinLnBrk="0" hangingPunct="1">
      <a:defRPr sz="1279" kern="1200">
        <a:solidFill>
          <a:schemeClr val="tx1"/>
        </a:solidFill>
        <a:latin typeface="+mn-lt"/>
        <a:ea typeface="+mn-ea"/>
        <a:cs typeface="+mn-cs"/>
      </a:defRPr>
    </a:lvl6pPr>
    <a:lvl7pPr marL="1949592" algn="l" defTabSz="649864" rtl="0" eaLnBrk="1" latinLnBrk="0" hangingPunct="1">
      <a:defRPr sz="1279" kern="1200">
        <a:solidFill>
          <a:schemeClr val="tx1"/>
        </a:solidFill>
        <a:latin typeface="+mn-lt"/>
        <a:ea typeface="+mn-ea"/>
        <a:cs typeface="+mn-cs"/>
      </a:defRPr>
    </a:lvl7pPr>
    <a:lvl8pPr marL="2274524" algn="l" defTabSz="649864" rtl="0" eaLnBrk="1" latinLnBrk="0" hangingPunct="1">
      <a:defRPr sz="1279" kern="1200">
        <a:solidFill>
          <a:schemeClr val="tx1"/>
        </a:solidFill>
        <a:latin typeface="+mn-lt"/>
        <a:ea typeface="+mn-ea"/>
        <a:cs typeface="+mn-cs"/>
      </a:defRPr>
    </a:lvl8pPr>
    <a:lvl9pPr marL="2599456" algn="l" defTabSz="649864" rtl="0" eaLnBrk="1" latinLnBrk="0" hangingPunct="1">
      <a:defRPr sz="127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05" userDrawn="1">
          <p15:clr>
            <a:srgbClr val="A4A3A4"/>
          </p15:clr>
        </p15:guide>
        <p15:guide id="2" pos="792" userDrawn="1">
          <p15:clr>
            <a:srgbClr val="A4A3A4"/>
          </p15:clr>
        </p15:guide>
        <p15:guide id="4" orient="horz" pos="273" userDrawn="1">
          <p15:clr>
            <a:srgbClr val="A4A3A4"/>
          </p15:clr>
        </p15:guide>
        <p15:guide id="6" pos="1584" userDrawn="1">
          <p15:clr>
            <a:srgbClr val="A4A3A4"/>
          </p15:clr>
        </p15:guide>
        <p15:guide id="7" pos="237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00"/>
    <a:srgbClr val="00FF00"/>
    <a:srgbClr val="0432FF"/>
    <a:srgbClr val="FF40FF"/>
    <a:srgbClr val="00FDFF"/>
    <a:srgbClr val="EC7E89"/>
    <a:srgbClr val="E97C84"/>
    <a:srgbClr val="F38288"/>
    <a:srgbClr val="CD5585"/>
    <a:srgbClr val="B84C7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8171"/>
    <p:restoredTop sz="97522" autoAdjust="0"/>
  </p:normalViewPr>
  <p:slideViewPr>
    <p:cSldViewPr snapToGrid="0" snapToObjects="1" showGuides="1">
      <p:cViewPr varScale="1">
        <p:scale>
          <a:sx n="112" d="100"/>
          <a:sy n="112" d="100"/>
        </p:scale>
        <p:origin x="1230" y="102"/>
      </p:cViewPr>
      <p:guideLst>
        <p:guide orient="horz" pos="1905"/>
        <p:guide pos="792"/>
        <p:guide orient="horz" pos="273"/>
        <p:guide pos="1584"/>
        <p:guide pos="237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1E4E17BB-95E6-1741-AE93-F169A843E57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2"/>
            <a:ext cx="4160520" cy="367030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DB4571-8095-BF4E-9420-401CC071600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5438458" y="2"/>
            <a:ext cx="4160520" cy="367030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r">
              <a:defRPr sz="1200"/>
            </a:lvl1pPr>
          </a:lstStyle>
          <a:p>
            <a:fld id="{B9A9A5A9-2048-DC45-862E-C0322B77F3FA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F423D1-2210-E745-A72E-F258121EE27D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6948171"/>
            <a:ext cx="4160520" cy="367029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297E99-20AD-2641-BB69-27E20118A8B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5438458" y="6948171"/>
            <a:ext cx="4160520" cy="367029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r">
              <a:defRPr sz="1200"/>
            </a:lvl1pPr>
          </a:lstStyle>
          <a:p>
            <a:fld id="{A1D5AC36-D550-FF41-ABB7-F6C6F1475B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38279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4160520" cy="367030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438458" y="2"/>
            <a:ext cx="4160520" cy="367030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r">
              <a:defRPr sz="1200"/>
            </a:lvl1pPr>
          </a:lstStyle>
          <a:p>
            <a:fld id="{3BD17408-84A5-CE4A-95E0-91CC3E57BB33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900488" y="914400"/>
            <a:ext cx="1800225" cy="24685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53" tIns="48327" rIns="96653" bIns="4832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60120" y="3520439"/>
            <a:ext cx="7680960" cy="2880361"/>
          </a:xfrm>
          <a:prstGeom prst="rect">
            <a:avLst/>
          </a:prstGeom>
        </p:spPr>
        <p:txBody>
          <a:bodyPr vert="horz" lIns="96653" tIns="48327" rIns="96653" bIns="48327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948171"/>
            <a:ext cx="4160520" cy="367029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438458" y="6948171"/>
            <a:ext cx="4160520" cy="367029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r">
              <a:defRPr sz="1200"/>
            </a:lvl1pPr>
          </a:lstStyle>
          <a:p>
            <a:fld id="{3138FF0E-91FE-BC42-9C7B-31BD5F457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9112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7190" y="1126780"/>
            <a:ext cx="4274820" cy="2396996"/>
          </a:xfrm>
        </p:spPr>
        <p:txBody>
          <a:bodyPr anchor="b"/>
          <a:lstStyle>
            <a:lvl1pPr algn="ctr">
              <a:defRPr sz="3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28650" y="3616213"/>
            <a:ext cx="3771900" cy="1662278"/>
          </a:xfrm>
        </p:spPr>
        <p:txBody>
          <a:bodyPr/>
          <a:lstStyle>
            <a:lvl1pPr marL="0" indent="0" algn="ctr">
              <a:buNone/>
              <a:defRPr sz="1320"/>
            </a:lvl1pPr>
            <a:lvl2pPr marL="251460" indent="0" algn="ctr">
              <a:buNone/>
              <a:defRPr sz="1100"/>
            </a:lvl2pPr>
            <a:lvl3pPr marL="502920" indent="0" algn="ctr">
              <a:buNone/>
              <a:defRPr sz="990"/>
            </a:lvl3pPr>
            <a:lvl4pPr marL="754380" indent="0" algn="ctr">
              <a:buNone/>
              <a:defRPr sz="880"/>
            </a:lvl4pPr>
            <a:lvl5pPr marL="1005840" indent="0" algn="ctr">
              <a:buNone/>
              <a:defRPr sz="880"/>
            </a:lvl5pPr>
            <a:lvl6pPr marL="1257300" indent="0" algn="ctr">
              <a:buNone/>
              <a:defRPr sz="880"/>
            </a:lvl6pPr>
            <a:lvl7pPr marL="1508760" indent="0" algn="ctr">
              <a:buNone/>
              <a:defRPr sz="880"/>
            </a:lvl7pPr>
            <a:lvl8pPr marL="1760220" indent="0" algn="ctr">
              <a:buNone/>
              <a:defRPr sz="880"/>
            </a:lvl8pPr>
            <a:lvl9pPr marL="2011680" indent="0" algn="ctr">
              <a:buNone/>
              <a:defRPr sz="8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373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43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599022" y="366562"/>
            <a:ext cx="1084421" cy="58347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5758" y="366562"/>
            <a:ext cx="3190399" cy="58347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07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7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138" y="1716468"/>
            <a:ext cx="4337685" cy="2863963"/>
          </a:xfrm>
        </p:spPr>
        <p:txBody>
          <a:bodyPr anchor="b"/>
          <a:lstStyle>
            <a:lvl1pPr>
              <a:defRPr sz="3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138" y="4607525"/>
            <a:ext cx="4337685" cy="1506091"/>
          </a:xfrm>
        </p:spPr>
        <p:txBody>
          <a:bodyPr/>
          <a:lstStyle>
            <a:lvl1pPr marL="0" indent="0">
              <a:buNone/>
              <a:defRPr sz="1320">
                <a:solidFill>
                  <a:schemeClr val="tx1"/>
                </a:solidFill>
              </a:defRPr>
            </a:lvl1pPr>
            <a:lvl2pPr marL="25146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2pPr>
            <a:lvl3pPr marL="502920" indent="0">
              <a:buNone/>
              <a:defRPr sz="990">
                <a:solidFill>
                  <a:schemeClr val="tx1">
                    <a:tint val="75000"/>
                  </a:schemeClr>
                </a:solidFill>
              </a:defRPr>
            </a:lvl3pPr>
            <a:lvl4pPr marL="754380" indent="0">
              <a:buNone/>
              <a:defRPr sz="880">
                <a:solidFill>
                  <a:schemeClr val="tx1">
                    <a:tint val="75000"/>
                  </a:schemeClr>
                </a:solidFill>
              </a:defRPr>
            </a:lvl4pPr>
            <a:lvl5pPr marL="1005840" indent="0">
              <a:buNone/>
              <a:defRPr sz="880">
                <a:solidFill>
                  <a:schemeClr val="tx1">
                    <a:tint val="75000"/>
                  </a:schemeClr>
                </a:solidFill>
              </a:defRPr>
            </a:lvl5pPr>
            <a:lvl6pPr marL="1257300" indent="0">
              <a:buNone/>
              <a:defRPr sz="880">
                <a:solidFill>
                  <a:schemeClr val="tx1">
                    <a:tint val="75000"/>
                  </a:schemeClr>
                </a:solidFill>
              </a:defRPr>
            </a:lvl6pPr>
            <a:lvl7pPr marL="1508760" indent="0">
              <a:buNone/>
              <a:defRPr sz="880">
                <a:solidFill>
                  <a:schemeClr val="tx1">
                    <a:tint val="75000"/>
                  </a:schemeClr>
                </a:solidFill>
              </a:defRPr>
            </a:lvl7pPr>
            <a:lvl8pPr marL="1760220" indent="0">
              <a:buNone/>
              <a:defRPr sz="880">
                <a:solidFill>
                  <a:schemeClr val="tx1">
                    <a:tint val="75000"/>
                  </a:schemeClr>
                </a:solidFill>
              </a:defRPr>
            </a:lvl8pPr>
            <a:lvl9pPr marL="2011680" indent="0">
              <a:buNone/>
              <a:defRPr sz="8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241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5758" y="1832809"/>
            <a:ext cx="2137410" cy="43684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46033" y="1832809"/>
            <a:ext cx="2137410" cy="43684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061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6413" y="366564"/>
            <a:ext cx="4337685" cy="133077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413" y="1687779"/>
            <a:ext cx="2127587" cy="827154"/>
          </a:xfrm>
        </p:spPr>
        <p:txBody>
          <a:bodyPr anchor="b"/>
          <a:lstStyle>
            <a:lvl1pPr marL="0" indent="0">
              <a:buNone/>
              <a:defRPr sz="1320" b="1"/>
            </a:lvl1pPr>
            <a:lvl2pPr marL="251460" indent="0">
              <a:buNone/>
              <a:defRPr sz="1100" b="1"/>
            </a:lvl2pPr>
            <a:lvl3pPr marL="502920" indent="0">
              <a:buNone/>
              <a:defRPr sz="990" b="1"/>
            </a:lvl3pPr>
            <a:lvl4pPr marL="754380" indent="0">
              <a:buNone/>
              <a:defRPr sz="880" b="1"/>
            </a:lvl4pPr>
            <a:lvl5pPr marL="1005840" indent="0">
              <a:buNone/>
              <a:defRPr sz="880" b="1"/>
            </a:lvl5pPr>
            <a:lvl6pPr marL="1257300" indent="0">
              <a:buNone/>
              <a:defRPr sz="880" b="1"/>
            </a:lvl6pPr>
            <a:lvl7pPr marL="1508760" indent="0">
              <a:buNone/>
              <a:defRPr sz="880" b="1"/>
            </a:lvl7pPr>
            <a:lvl8pPr marL="1760220" indent="0">
              <a:buNone/>
              <a:defRPr sz="880" b="1"/>
            </a:lvl8pPr>
            <a:lvl9pPr marL="2011680" indent="0">
              <a:buNone/>
              <a:defRPr sz="8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413" y="2514933"/>
            <a:ext cx="2127587" cy="36990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46033" y="1687779"/>
            <a:ext cx="2138065" cy="827154"/>
          </a:xfrm>
        </p:spPr>
        <p:txBody>
          <a:bodyPr anchor="b"/>
          <a:lstStyle>
            <a:lvl1pPr marL="0" indent="0">
              <a:buNone/>
              <a:defRPr sz="1320" b="1"/>
            </a:lvl1pPr>
            <a:lvl2pPr marL="251460" indent="0">
              <a:buNone/>
              <a:defRPr sz="1100" b="1"/>
            </a:lvl2pPr>
            <a:lvl3pPr marL="502920" indent="0">
              <a:buNone/>
              <a:defRPr sz="990" b="1"/>
            </a:lvl3pPr>
            <a:lvl4pPr marL="754380" indent="0">
              <a:buNone/>
              <a:defRPr sz="880" b="1"/>
            </a:lvl4pPr>
            <a:lvl5pPr marL="1005840" indent="0">
              <a:buNone/>
              <a:defRPr sz="880" b="1"/>
            </a:lvl5pPr>
            <a:lvl6pPr marL="1257300" indent="0">
              <a:buNone/>
              <a:defRPr sz="880" b="1"/>
            </a:lvl6pPr>
            <a:lvl7pPr marL="1508760" indent="0">
              <a:buNone/>
              <a:defRPr sz="880" b="1"/>
            </a:lvl7pPr>
            <a:lvl8pPr marL="1760220" indent="0">
              <a:buNone/>
              <a:defRPr sz="880" b="1"/>
            </a:lvl8pPr>
            <a:lvl9pPr marL="2011680" indent="0">
              <a:buNone/>
              <a:defRPr sz="8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46033" y="2514933"/>
            <a:ext cx="2138065" cy="36990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1955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523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259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6413" y="458999"/>
            <a:ext cx="1622048" cy="1606497"/>
          </a:xfrm>
        </p:spPr>
        <p:txBody>
          <a:bodyPr anchor="b"/>
          <a:lstStyle>
            <a:lvl1pPr>
              <a:defRPr sz="1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38065" y="991312"/>
            <a:ext cx="2546033" cy="4892804"/>
          </a:xfrm>
        </p:spPr>
        <p:txBody>
          <a:bodyPr/>
          <a:lstStyle>
            <a:lvl1pPr>
              <a:defRPr sz="1760"/>
            </a:lvl1pPr>
            <a:lvl2pPr>
              <a:defRPr sz="1540"/>
            </a:lvl2pPr>
            <a:lvl3pPr>
              <a:defRPr sz="132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6413" y="2065496"/>
            <a:ext cx="1622048" cy="3826588"/>
          </a:xfrm>
        </p:spPr>
        <p:txBody>
          <a:bodyPr/>
          <a:lstStyle>
            <a:lvl1pPr marL="0" indent="0">
              <a:buNone/>
              <a:defRPr sz="880"/>
            </a:lvl1pPr>
            <a:lvl2pPr marL="251460" indent="0">
              <a:buNone/>
              <a:defRPr sz="770"/>
            </a:lvl2pPr>
            <a:lvl3pPr marL="502920" indent="0">
              <a:buNone/>
              <a:defRPr sz="660"/>
            </a:lvl3pPr>
            <a:lvl4pPr marL="754380" indent="0">
              <a:buNone/>
              <a:defRPr sz="550"/>
            </a:lvl4pPr>
            <a:lvl5pPr marL="1005840" indent="0">
              <a:buNone/>
              <a:defRPr sz="550"/>
            </a:lvl5pPr>
            <a:lvl6pPr marL="1257300" indent="0">
              <a:buNone/>
              <a:defRPr sz="550"/>
            </a:lvl6pPr>
            <a:lvl7pPr marL="1508760" indent="0">
              <a:buNone/>
              <a:defRPr sz="550"/>
            </a:lvl7pPr>
            <a:lvl8pPr marL="1760220" indent="0">
              <a:buNone/>
              <a:defRPr sz="550"/>
            </a:lvl8pPr>
            <a:lvl9pPr marL="2011680" indent="0">
              <a:buNone/>
              <a:defRPr sz="5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015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6413" y="458999"/>
            <a:ext cx="1622048" cy="1606497"/>
          </a:xfrm>
        </p:spPr>
        <p:txBody>
          <a:bodyPr anchor="b"/>
          <a:lstStyle>
            <a:lvl1pPr>
              <a:defRPr sz="1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38065" y="991312"/>
            <a:ext cx="2546033" cy="4892804"/>
          </a:xfrm>
        </p:spPr>
        <p:txBody>
          <a:bodyPr anchor="t"/>
          <a:lstStyle>
            <a:lvl1pPr marL="0" indent="0">
              <a:buNone/>
              <a:defRPr sz="1760"/>
            </a:lvl1pPr>
            <a:lvl2pPr marL="251460" indent="0">
              <a:buNone/>
              <a:defRPr sz="1540"/>
            </a:lvl2pPr>
            <a:lvl3pPr marL="502920" indent="0">
              <a:buNone/>
              <a:defRPr sz="1320"/>
            </a:lvl3pPr>
            <a:lvl4pPr marL="754380" indent="0">
              <a:buNone/>
              <a:defRPr sz="1100"/>
            </a:lvl4pPr>
            <a:lvl5pPr marL="1005840" indent="0">
              <a:buNone/>
              <a:defRPr sz="1100"/>
            </a:lvl5pPr>
            <a:lvl6pPr marL="1257300" indent="0">
              <a:buNone/>
              <a:defRPr sz="1100"/>
            </a:lvl6pPr>
            <a:lvl7pPr marL="1508760" indent="0">
              <a:buNone/>
              <a:defRPr sz="1100"/>
            </a:lvl7pPr>
            <a:lvl8pPr marL="1760220" indent="0">
              <a:buNone/>
              <a:defRPr sz="1100"/>
            </a:lvl8pPr>
            <a:lvl9pPr marL="2011680" indent="0">
              <a:buNone/>
              <a:defRPr sz="1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6413" y="2065496"/>
            <a:ext cx="1622048" cy="3826588"/>
          </a:xfrm>
        </p:spPr>
        <p:txBody>
          <a:bodyPr/>
          <a:lstStyle>
            <a:lvl1pPr marL="0" indent="0">
              <a:buNone/>
              <a:defRPr sz="880"/>
            </a:lvl1pPr>
            <a:lvl2pPr marL="251460" indent="0">
              <a:buNone/>
              <a:defRPr sz="770"/>
            </a:lvl2pPr>
            <a:lvl3pPr marL="502920" indent="0">
              <a:buNone/>
              <a:defRPr sz="660"/>
            </a:lvl3pPr>
            <a:lvl4pPr marL="754380" indent="0">
              <a:buNone/>
              <a:defRPr sz="550"/>
            </a:lvl4pPr>
            <a:lvl5pPr marL="1005840" indent="0">
              <a:buNone/>
              <a:defRPr sz="550"/>
            </a:lvl5pPr>
            <a:lvl6pPr marL="1257300" indent="0">
              <a:buNone/>
              <a:defRPr sz="550"/>
            </a:lvl6pPr>
            <a:lvl7pPr marL="1508760" indent="0">
              <a:buNone/>
              <a:defRPr sz="550"/>
            </a:lvl7pPr>
            <a:lvl8pPr marL="1760220" indent="0">
              <a:buNone/>
              <a:defRPr sz="550"/>
            </a:lvl8pPr>
            <a:lvl9pPr marL="2011680" indent="0">
              <a:buNone/>
              <a:defRPr sz="5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20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5758" y="366564"/>
            <a:ext cx="4337685" cy="133077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5758" y="1832809"/>
            <a:ext cx="4337685" cy="43684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5758" y="6381365"/>
            <a:ext cx="1131570" cy="3665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A0D40-68A1-F040-9BD5-36D632BB7D3C}" type="datetimeFigureOut">
              <a:rPr lang="en-US" smtClean="0"/>
              <a:t>7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5923" y="6381365"/>
            <a:ext cx="1697355" cy="3665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1873" y="6381365"/>
            <a:ext cx="1131570" cy="3665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278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02920" rtl="0" eaLnBrk="1" latinLnBrk="0" hangingPunct="1">
        <a:lnSpc>
          <a:spcPct val="90000"/>
        </a:lnSpc>
        <a:spcBef>
          <a:spcPct val="0"/>
        </a:spcBef>
        <a:buNone/>
        <a:defRPr sz="24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5730" indent="-125730" algn="l" defTabSz="50292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540" kern="1200">
          <a:solidFill>
            <a:schemeClr val="tx1"/>
          </a:solidFill>
          <a:latin typeface="+mn-lt"/>
          <a:ea typeface="+mn-ea"/>
          <a:cs typeface="+mn-cs"/>
        </a:defRPr>
      </a:lvl1pPr>
      <a:lvl2pPr marL="37719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2pPr>
      <a:lvl3pPr marL="62865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3pPr>
      <a:lvl4pPr marL="88011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990" kern="1200">
          <a:solidFill>
            <a:schemeClr val="tx1"/>
          </a:solidFill>
          <a:latin typeface="+mn-lt"/>
          <a:ea typeface="+mn-ea"/>
          <a:cs typeface="+mn-cs"/>
        </a:defRPr>
      </a:lvl4pPr>
      <a:lvl5pPr marL="113157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990" kern="1200">
          <a:solidFill>
            <a:schemeClr val="tx1"/>
          </a:solidFill>
          <a:latin typeface="+mn-lt"/>
          <a:ea typeface="+mn-ea"/>
          <a:cs typeface="+mn-cs"/>
        </a:defRPr>
      </a:lvl5pPr>
      <a:lvl6pPr marL="138303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990" kern="1200">
          <a:solidFill>
            <a:schemeClr val="tx1"/>
          </a:solidFill>
          <a:latin typeface="+mn-lt"/>
          <a:ea typeface="+mn-ea"/>
          <a:cs typeface="+mn-cs"/>
        </a:defRPr>
      </a:lvl6pPr>
      <a:lvl7pPr marL="163449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990" kern="1200">
          <a:solidFill>
            <a:schemeClr val="tx1"/>
          </a:solidFill>
          <a:latin typeface="+mn-lt"/>
          <a:ea typeface="+mn-ea"/>
          <a:cs typeface="+mn-cs"/>
        </a:defRPr>
      </a:lvl7pPr>
      <a:lvl8pPr marL="188595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990" kern="1200">
          <a:solidFill>
            <a:schemeClr val="tx1"/>
          </a:solidFill>
          <a:latin typeface="+mn-lt"/>
          <a:ea typeface="+mn-ea"/>
          <a:cs typeface="+mn-cs"/>
        </a:defRPr>
      </a:lvl8pPr>
      <a:lvl9pPr marL="213741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9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1pPr>
      <a:lvl2pPr marL="25146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2pPr>
      <a:lvl3pPr marL="50292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3pPr>
      <a:lvl4pPr marL="75438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4pPr>
      <a:lvl5pPr marL="100584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5pPr>
      <a:lvl6pPr marL="125730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6pPr>
      <a:lvl7pPr marL="150876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7pPr>
      <a:lvl8pPr marL="176022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8pPr>
      <a:lvl9pPr marL="201168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B25B5BD9-C500-B244-A8BC-A80C21DA352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" r="24165" b="2800"/>
          <a:stretch/>
        </p:blipFill>
        <p:spPr>
          <a:xfrm>
            <a:off x="2630177" y="864275"/>
            <a:ext cx="1456048" cy="273419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4EF4962-5FA4-6F43-AD1D-CA26C2DE03F2}"/>
              </a:ext>
            </a:extLst>
          </p:cNvPr>
          <p:cNvSpPr txBox="1"/>
          <p:nvPr/>
        </p:nvSpPr>
        <p:spPr>
          <a:xfrm>
            <a:off x="311645" y="684932"/>
            <a:ext cx="14334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CN      PCT       PS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355F25B-8B5D-6D4A-AE18-110340649B24}"/>
              </a:ext>
            </a:extLst>
          </p:cNvPr>
          <p:cNvSpPr txBox="1"/>
          <p:nvPr/>
        </p:nvSpPr>
        <p:spPr>
          <a:xfrm>
            <a:off x="2755998" y="684932"/>
            <a:ext cx="13997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CT/PCN   PST/PSN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C697EE1C-22DE-6847-BB7B-FC7732B3A83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8066" b="1728"/>
          <a:stretch/>
        </p:blipFill>
        <p:spPr>
          <a:xfrm>
            <a:off x="92406" y="864276"/>
            <a:ext cx="1638885" cy="5688133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7369EB5-0CA8-3F4F-BF45-726AC488BEF2}"/>
              </a:ext>
            </a:extLst>
          </p:cNvPr>
          <p:cNvSpPr txBox="1"/>
          <p:nvPr/>
        </p:nvSpPr>
        <p:spPr>
          <a:xfrm>
            <a:off x="119644" y="-20626"/>
            <a:ext cx="47164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eatmaps of genes altered by spinach consumption in the rat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094EC2D-8966-974D-A78F-6E89B353785B}"/>
              </a:ext>
            </a:extLst>
          </p:cNvPr>
          <p:cNvSpPr/>
          <p:nvPr/>
        </p:nvSpPr>
        <p:spPr>
          <a:xfrm>
            <a:off x="2561613" y="295736"/>
            <a:ext cx="173048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umor-associated genes normalized by SPI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0C51F214-8CDD-4D47-81B5-57570EA85EF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8748" r="6916" b="91459"/>
          <a:stretch/>
        </p:blipFill>
        <p:spPr>
          <a:xfrm>
            <a:off x="2370155" y="3144395"/>
            <a:ext cx="191458" cy="1091142"/>
          </a:xfrm>
          <a:prstGeom prst="rect">
            <a:avLst/>
          </a:prstGeom>
        </p:spPr>
      </p:pic>
      <p:sp>
        <p:nvSpPr>
          <p:cNvPr id="44" name="Rectangle 43">
            <a:extLst>
              <a:ext uri="{FF2B5EF4-FFF2-40B4-BE49-F238E27FC236}">
                <a16:creationId xmlns:a16="http://schemas.microsoft.com/office/drawing/2014/main" id="{424E8459-CEA1-48BD-B22C-A6701F00889D}"/>
              </a:ext>
            </a:extLst>
          </p:cNvPr>
          <p:cNvSpPr/>
          <p:nvPr/>
        </p:nvSpPr>
        <p:spPr>
          <a:xfrm>
            <a:off x="190601" y="310056"/>
            <a:ext cx="162498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PI-altered genes in Pirc normal-looking colo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4E9B3EA-9B1C-406F-894D-8F0CA6B77596}"/>
              </a:ext>
            </a:extLst>
          </p:cNvPr>
          <p:cNvSpPr txBox="1"/>
          <p:nvPr/>
        </p:nvSpPr>
        <p:spPr>
          <a:xfrm>
            <a:off x="0" y="283324"/>
            <a:ext cx="2570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CA72CE6-6FB4-42A9-A323-B0D35293DABB}"/>
              </a:ext>
            </a:extLst>
          </p:cNvPr>
          <p:cNvSpPr txBox="1"/>
          <p:nvPr/>
        </p:nvSpPr>
        <p:spPr>
          <a:xfrm>
            <a:off x="2477892" y="281567"/>
            <a:ext cx="2570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91BD32C-4BA0-4D6B-AE2F-3116CD772E72}"/>
              </a:ext>
            </a:extLst>
          </p:cNvPr>
          <p:cNvSpPr txBox="1"/>
          <p:nvPr/>
        </p:nvSpPr>
        <p:spPr>
          <a:xfrm>
            <a:off x="1897865" y="301647"/>
            <a:ext cx="262892" cy="658334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tra6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cl20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Kifl9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tse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Ltbp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hrd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Jak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gnl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Fcer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erpine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lcxd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Alpl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Dgat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t3gal4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Itgb6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MMp1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mem17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Defa6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Noxo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Defa8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lr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Duoxa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Fasn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ol6a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Hk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gcb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Abcc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Igfbp6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cng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Rasl1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Bmp5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Gsn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2ry14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Mov10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lc22a5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yp3a9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span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lc41a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Bco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Eno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f4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ppp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lc30a10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Aldh1a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Glul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Aox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lc37a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askin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la2g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apss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sc22d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Ahrr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tk17b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Osgin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ry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cnn1a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Gluca2a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migd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Rhod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lc26a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lcd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Mep1a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Mapre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mah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Gnb5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pa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Mettl7b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Arl4d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Amigo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Grem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Rims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Krt20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ldn2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mp2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av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Eepd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Kcnd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ynpo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pp1r3c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ns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agln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Acta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srp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acr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ygm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Hspb6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cp4l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f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dim4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pa6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cf7l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pp1r14a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E1541B8E-AEDF-4EA1-B34E-1359FF6D7815}"/>
              </a:ext>
            </a:extLst>
          </p:cNvPr>
          <p:cNvCxnSpPr>
            <a:cxnSpLocks/>
          </p:cNvCxnSpPr>
          <p:nvPr/>
        </p:nvCxnSpPr>
        <p:spPr>
          <a:xfrm flipH="1">
            <a:off x="1731885" y="326026"/>
            <a:ext cx="149880" cy="593222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486BC0BB-6790-4AAF-97B0-C2D1C8603954}"/>
              </a:ext>
            </a:extLst>
          </p:cNvPr>
          <p:cNvCxnSpPr>
            <a:cxnSpLocks/>
          </p:cNvCxnSpPr>
          <p:nvPr/>
        </p:nvCxnSpPr>
        <p:spPr>
          <a:xfrm flipH="1" flipV="1">
            <a:off x="1727542" y="6550028"/>
            <a:ext cx="158944" cy="22701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2E4CF67F-4007-4A6B-A269-5D483CB2BB47}"/>
              </a:ext>
            </a:extLst>
          </p:cNvPr>
          <p:cNvSpPr txBox="1"/>
          <p:nvPr/>
        </p:nvSpPr>
        <p:spPr>
          <a:xfrm>
            <a:off x="4381294" y="764669"/>
            <a:ext cx="325410" cy="304391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rpsap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Recql5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pne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cml4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Grpel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usd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cdh17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Rundc3a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RGD621098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p53i1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Gtf2ird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tprj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Rgs1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Rrm2b</a:t>
            </a:r>
          </a:p>
          <a:p>
            <a:r>
              <a:rPr lang="en-US" sz="460" i="1" dirty="0">
                <a:solidFill>
                  <a:srgbClr val="00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if2b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lekhg5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Lfng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Inmt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Klf7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d7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ecam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Add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lcl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Radil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Serpinb9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Kcnq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Dusp8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Bgn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cl2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Enpp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Nt5c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Mtus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Nlgn3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Tmc8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Acta1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Il22ra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Psmb8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Adtrp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dc42bpa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Herpud2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Art2b</a:t>
            </a:r>
          </a:p>
          <a:p>
            <a:r>
              <a:rPr lang="en-US" sz="460" i="1" dirty="0">
                <a:latin typeface="Arial" panose="020B0604020202020204" pitchFamily="34" charset="0"/>
                <a:cs typeface="Arial" panose="020B0604020202020204" pitchFamily="34" charset="0"/>
              </a:rPr>
              <a:t>Cpxm2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69A2CBAF-4652-45E4-A8A5-981F91DE1148}"/>
              </a:ext>
            </a:extLst>
          </p:cNvPr>
          <p:cNvCxnSpPr>
            <a:cxnSpLocks/>
          </p:cNvCxnSpPr>
          <p:nvPr/>
        </p:nvCxnSpPr>
        <p:spPr>
          <a:xfrm flipH="1">
            <a:off x="4084438" y="790575"/>
            <a:ext cx="271466" cy="128673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09667FC0-9A49-472C-B314-52E902CC0C9C}"/>
              </a:ext>
            </a:extLst>
          </p:cNvPr>
          <p:cNvCxnSpPr>
            <a:cxnSpLocks/>
          </p:cNvCxnSpPr>
          <p:nvPr/>
        </p:nvCxnSpPr>
        <p:spPr>
          <a:xfrm flipH="1" flipV="1">
            <a:off x="4083372" y="3594837"/>
            <a:ext cx="272532" cy="14610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Arrow: Right 1">
            <a:extLst>
              <a:ext uri="{FF2B5EF4-FFF2-40B4-BE49-F238E27FC236}">
                <a16:creationId xmlns:a16="http://schemas.microsoft.com/office/drawing/2014/main" id="{A2765766-4AA3-44AA-8E80-9751348A27A2}"/>
              </a:ext>
            </a:extLst>
          </p:cNvPr>
          <p:cNvSpPr/>
          <p:nvPr/>
        </p:nvSpPr>
        <p:spPr>
          <a:xfrm flipH="1">
            <a:off x="4596416" y="1738737"/>
            <a:ext cx="151712" cy="71998"/>
          </a:xfrm>
          <a:prstGeom prst="rightArrow">
            <a:avLst/>
          </a:prstGeom>
          <a:solidFill>
            <a:srgbClr val="0066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0653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15</TotalTime>
  <Words>168</Words>
  <Application>Microsoft Office PowerPoint</Application>
  <PresentationFormat>Custom</PresentationFormat>
  <Paragraphs>1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ng-Shiuan Chen</dc:creator>
  <cp:lastModifiedBy>Dashwood, Roderick H</cp:lastModifiedBy>
  <cp:revision>478</cp:revision>
  <cp:lastPrinted>2020-01-07T17:16:05Z</cp:lastPrinted>
  <dcterms:created xsi:type="dcterms:W3CDTF">2018-06-27T19:28:06Z</dcterms:created>
  <dcterms:modified xsi:type="dcterms:W3CDTF">2021-07-01T17:57:26Z</dcterms:modified>
</cp:coreProperties>
</file>